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278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FC31A-2E66-4145-9424-BFF2F2D2B10E}" type="datetimeFigureOut">
              <a:rPr lang="es-ES" smtClean="0"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E0E2E-3F66-42E7-98C8-9C5097FD5C7F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3 Tabla"/>
          <p:cNvGraphicFramePr>
            <a:graphicFrameLocks noGrp="1"/>
          </p:cNvGraphicFramePr>
          <p:nvPr/>
        </p:nvGraphicFramePr>
        <p:xfrm>
          <a:off x="323528" y="776411"/>
          <a:ext cx="8461340" cy="5394613"/>
        </p:xfrm>
        <a:graphic>
          <a:graphicData uri="http://schemas.openxmlformats.org/drawingml/2006/table">
            <a:tbl>
              <a:tblPr/>
              <a:tblGrid>
                <a:gridCol w="1053482"/>
                <a:gridCol w="1379895"/>
                <a:gridCol w="1492994"/>
                <a:gridCol w="1412049"/>
                <a:gridCol w="1597773"/>
                <a:gridCol w="1525147"/>
              </a:tblGrid>
              <a:tr h="474795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reatment 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TPA-extractable soil </a:t>
                      </a:r>
                      <a:r>
                        <a:rPr lang="en-GB" sz="1100" dirty="0" err="1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d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(mg kg</a:t>
                      </a:r>
                      <a:r>
                        <a:rPr lang="en-GB" sz="1100" baseline="300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TPA-extractable soil Zn (mg kg</a:t>
                      </a:r>
                      <a:r>
                        <a:rPr lang="en-GB" sz="1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oot DW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(g plant</a:t>
                      </a:r>
                      <a:r>
                        <a:rPr lang="es-ES" sz="1100" baseline="30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oot length (cm)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verage root diameter (mm)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65756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No-Cd 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2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3</a:t>
                      </a: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8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5</a:t>
                      </a: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3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2</a:t>
                      </a: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9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4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3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8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5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3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22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3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42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71 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35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78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4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8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4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5756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5-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21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9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33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6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47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1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5</a:t>
                      </a: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7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2</a:t>
                      </a: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7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1</a:t>
                      </a: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5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1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7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06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41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79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53 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75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55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4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5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5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5756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-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93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3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72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3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20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12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2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4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2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5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4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1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2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1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2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4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00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0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21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33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99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3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7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7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3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0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6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47635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reatment 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Shoot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DW 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(g plant</a:t>
                      </a:r>
                      <a:r>
                        <a:rPr lang="es-ES" sz="1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-1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hoot </a:t>
                      </a:r>
                      <a:r>
                        <a:rPr lang="en-GB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d</a:t>
                      </a: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concentration (mg kg</a:t>
                      </a:r>
                      <a:r>
                        <a:rPr lang="en-GB" sz="1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hoot Zn concentration (mg kg</a:t>
                      </a:r>
                      <a:r>
                        <a:rPr lang="en-GB" sz="1100" baseline="300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hoot </a:t>
                      </a:r>
                      <a:r>
                        <a:rPr lang="en-GB" sz="1100" dirty="0" err="1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hytate:Zn</a:t>
                      </a:r>
                      <a:r>
                        <a:rPr lang="en-GB" sz="1100" baseline="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ratio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hoot </a:t>
                      </a:r>
                      <a:r>
                        <a:rPr lang="en-GB" sz="1100" baseline="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rotein </a:t>
                      </a: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centration (g kg</a:t>
                      </a:r>
                      <a:r>
                        <a:rPr lang="en-GB" sz="1100" baseline="300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65756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No-Cd 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6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4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8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3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*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*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*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3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2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3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8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0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7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5.6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6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.3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9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.9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0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1.0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4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1.7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5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1.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6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65756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5-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2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 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8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3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2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2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7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3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 c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0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3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7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7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0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6.4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4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.6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0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.8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0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1.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4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2.0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9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2.3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9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65756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-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0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2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8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3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2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2 a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7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2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6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3 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8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6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7.9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2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.1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5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.5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6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1.1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9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1.1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4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0.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9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0" y="112914"/>
            <a:ext cx="8892480" cy="6131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GB" sz="12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1</a:t>
            </a:r>
            <a:r>
              <a:rPr lang="en-GB" sz="12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GB" sz="12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able</a:t>
            </a:r>
            <a:r>
              <a:rPr lang="en-GB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lang="en-GB" sz="12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Mean ± standard error of DTPA-extractable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oil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d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nd Zn, root DW, root length, average root diameter, shoot DW, shoot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d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nd Zn concentrations,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tate:Zn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molar ratio and shoot protein concentration in </a:t>
            </a:r>
            <a:r>
              <a:rPr lang="en-AU" sz="1200" b="1" i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L</a:t>
            </a:r>
            <a:r>
              <a:rPr kumimoji="0" lang="en-GB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kumimoji="0" lang="en-GB" sz="12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rigidum</a:t>
            </a:r>
            <a:r>
              <a:rPr kumimoji="0" lang="en-GB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s-E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179512" y="6279703"/>
            <a:ext cx="437042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 Detection limit &lt; 0.002 mg kg</a:t>
            </a:r>
            <a:r>
              <a:rPr kumimoji="0" lang="en-GB" sz="1200" b="0" i="0" u="none" strike="noStrike" cap="none" normalizeH="0" baseline="3000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-1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for soil DTPA-extractable soil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d</a:t>
            </a:r>
            <a:endParaRPr kumimoji="0" lang="es-ES" sz="1200" b="0" i="0" u="none" strike="noStrike" cap="none" normalizeH="0" baseline="0" dirty="0" smtClean="0">
              <a:ln>
                <a:noFill/>
              </a:ln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* Detection limit &lt; 0.05 mg kg</a:t>
            </a:r>
            <a:r>
              <a:rPr kumimoji="0" lang="en-GB" sz="1200" b="0" i="0" u="none" strike="noStrike" cap="none" normalizeH="0" baseline="3000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-1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for digested plants</a:t>
            </a:r>
            <a:endParaRPr kumimoji="0" lang="en-GB" sz="1200" b="0" i="0" u="none" strike="noStrike" cap="none" normalizeH="0" baseline="0" dirty="0" smtClean="0">
              <a:ln>
                <a:noFill/>
              </a:ln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63</Words>
  <Application>Microsoft Office PowerPoint</Application>
  <PresentationFormat>Presentación en pantalla (4:3)</PresentationFormat>
  <Paragraphs>16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suario</dc:creator>
  <cp:lastModifiedBy>usuario</cp:lastModifiedBy>
  <cp:revision>1</cp:revision>
  <dcterms:created xsi:type="dcterms:W3CDTF">2017-09-15T08:58:34Z</dcterms:created>
  <dcterms:modified xsi:type="dcterms:W3CDTF">2017-09-15T09:00:09Z</dcterms:modified>
</cp:coreProperties>
</file>